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A61AC-B597-4065-8129-5885A10122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0A4BF-BFA1-4798-A3B7-31364FB76D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81369A-157D-471D-BE59-3D0092B383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746E6D-C263-412D-AD33-939B92C00A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9C8D1-4F43-4758-B851-2FA6858BE3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5D011-83F7-4E43-9A47-59A8F0F710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6697A-E02A-4A79-9230-E7820CB4C5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4CF2E-3366-43B0-85C1-A5AA8A61E1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11797-5D09-400C-9A4B-FCF2410C4F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BE916-EB7A-4C90-8D21-8E59C02A54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B1ADB-67DD-48B4-A676-1504F05C17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6527D-CA08-4FE2-BC50-8B1C16D219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BFADB95-EEB0-4D55-A6E8-E6212DDD8C75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F4F016A-7019-46AD-9199-1B21C4CF78C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072"/>
          <p:cNvSpPr/>
          <p:nvPr/>
        </p:nvSpPr>
        <p:spPr>
          <a:xfrm>
            <a:off x="339840" y="5146560"/>
            <a:ext cx="8582040" cy="167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A2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alization of wild-type Wag31 and nascent peptidoglycan biosynthesis in the presence or absence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knA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Mt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overexpression. Early-log phase cell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. smegmati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KMS2) containing pCK314 were divided into two flasks,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knA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Mt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was expressed in one of the flasks for 2 hr by adding 0.1% of acetamide. Subsequently, both cultures were incubated with tetracycline (20 ng ml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for 2 hr to express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fp-wag31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Mt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examined by a florescent microscope. For vancomycin staining, Van-Alexa568 (5 mg/ml) was added to each culture at the end of tetracycline induction and further incubated for 20 min before examining by a fluorescence microscope. Average GFP and Van-Alex568 intensity from cells with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knA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Mt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overexpression relative to that of cells without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knA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Mt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overexpression are shown at the bottom of each panel.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value for the difference in GFP signals = 1.00 X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and for Van-Alexa568 signals = 0.004). Bar, 5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117"/>
          <p:cNvSpPr/>
          <p:nvPr/>
        </p:nvSpPr>
        <p:spPr>
          <a:xfrm>
            <a:off x="5996160" y="612144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6" descr=""/>
          <p:cNvPicPr/>
          <p:nvPr/>
        </p:nvPicPr>
        <p:blipFill>
          <a:blip r:embed="rId1"/>
          <a:stretch/>
        </p:blipFill>
        <p:spPr>
          <a:xfrm>
            <a:off x="3468600" y="595440"/>
            <a:ext cx="3384720" cy="17841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9" descr=""/>
          <p:cNvPicPr/>
          <p:nvPr/>
        </p:nvPicPr>
        <p:blipFill>
          <a:blip r:embed="rId2"/>
          <a:stretch/>
        </p:blipFill>
        <p:spPr>
          <a:xfrm>
            <a:off x="3468600" y="2759040"/>
            <a:ext cx="3398760" cy="17924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5" name=""/>
          <p:cNvGraphicFramePr/>
          <p:nvPr/>
        </p:nvGraphicFramePr>
        <p:xfrm>
          <a:off x="2262240" y="309600"/>
          <a:ext cx="4600440" cy="4635360"/>
        </p:xfrm>
        <a:graphic>
          <a:graphicData uri="http://schemas.openxmlformats.org/drawingml/2006/table">
            <a:tbl>
              <a:tblPr/>
              <a:tblGrid>
                <a:gridCol w="473040"/>
                <a:gridCol w="735120"/>
                <a:gridCol w="1695240"/>
                <a:gridCol w="1697040"/>
              </a:tblGrid>
              <a:tr h="301320"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pknA</a:t>
                      </a:r>
                      <a:r>
                        <a:rPr b="1" i="1" lang="en-US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pknA</a:t>
                      </a:r>
                      <a:r>
                        <a:rPr b="1" i="1" lang="en-US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97320">
                <a:tc rowSpan="2">
                  <a:txBody>
                    <a:bodyPr lIns="90000" rIns="90000" tIns="46800" bIns="46800" anchor="t" anchorCtr="1" vert="eaVer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ocalization of Wag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FP-Wag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03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8520">
                <a:tc>
                  <a:txBody>
                    <a:bodyPr lIns="90000" rIns="90000" tIns="46800" bIns="46800" anchor="t" anchorCtr="1" vert="eaVer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lative intens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07400">
                <a:tc rowSpan="2">
                  <a:txBody>
                    <a:bodyPr lIns="90000" rIns="90000" tIns="46800" bIns="46800" anchor="t" anchorCtr="1" vert="eaVer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scent Peptidoglycan synthesi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an-Alexa5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8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8520">
                <a:tc>
                  <a:txBody>
                    <a:bodyPr lIns="90000" rIns="90000" tIns="46800" bIns="46800" anchor="t" anchorCtr="1" vert="eaVer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lative intens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Straight Connector 7"/>
          <p:cNvSpPr/>
          <p:nvPr/>
        </p:nvSpPr>
        <p:spPr>
          <a:xfrm>
            <a:off x="6566040" y="2279520"/>
            <a:ext cx="228600" cy="1800"/>
          </a:xfrm>
          <a:prstGeom prst="line">
            <a:avLst/>
          </a:prstGeom>
          <a:ln w="25560">
            <a:solidFill>
              <a:srgbClr val="4a452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8"/>
          <p:cNvSpPr/>
          <p:nvPr/>
        </p:nvSpPr>
        <p:spPr>
          <a:xfrm>
            <a:off x="6567480" y="4452840"/>
            <a:ext cx="228600" cy="1800"/>
          </a:xfrm>
          <a:prstGeom prst="line">
            <a:avLst/>
          </a:prstGeom>
          <a:ln w="25560">
            <a:solidFill>
              <a:srgbClr val="4a452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10"/>
          <p:cNvSpPr/>
          <p:nvPr/>
        </p:nvSpPr>
        <p:spPr>
          <a:xfrm>
            <a:off x="4871880" y="4449600"/>
            <a:ext cx="228600" cy="1800"/>
          </a:xfrm>
          <a:prstGeom prst="line">
            <a:avLst/>
          </a:prstGeom>
          <a:ln w="25560">
            <a:solidFill>
              <a:srgbClr val="4a452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11"/>
          <p:cNvSpPr/>
          <p:nvPr/>
        </p:nvSpPr>
        <p:spPr>
          <a:xfrm>
            <a:off x="5024520" y="4602240"/>
            <a:ext cx="22860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12"/>
          <p:cNvSpPr/>
          <p:nvPr/>
        </p:nvSpPr>
        <p:spPr>
          <a:xfrm>
            <a:off x="4865760" y="2282760"/>
            <a:ext cx="228600" cy="1800"/>
          </a:xfrm>
          <a:prstGeom prst="line">
            <a:avLst/>
          </a:prstGeom>
          <a:ln w="25560">
            <a:solidFill>
              <a:srgbClr val="4a452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1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1T20:16:39Z</dcterms:created>
  <dc:creator>Office 2004 Test Drive User</dc:creator>
  <dc:description/>
  <dc:language>en-US</dc:language>
  <cp:lastModifiedBy>Choong-Min Kang</cp:lastModifiedBy>
  <cp:lastPrinted>2010-08-02T20:49:52Z</cp:lastPrinted>
  <dcterms:modified xsi:type="dcterms:W3CDTF">2010-12-16T14:40:21Z</dcterms:modified>
  <cp:revision>188</cp:revision>
  <dc:subject/>
  <dc:title>Slide 1</dc:title>
</cp:coreProperties>
</file>